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1"/>
    <p:restoredTop sz="94679"/>
  </p:normalViewPr>
  <p:slideViewPr>
    <p:cSldViewPr snapToGrid="0" snapToObjects="1" showGuides="1">
      <p:cViewPr>
        <p:scale>
          <a:sx n="96" d="100"/>
          <a:sy n="96" d="100"/>
        </p:scale>
        <p:origin x="56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6006498"/>
              </p:ext>
            </p:extLst>
          </p:nvPr>
        </p:nvGraphicFramePr>
        <p:xfrm>
          <a:off x="1170035" y="1928222"/>
          <a:ext cx="4153928" cy="76009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38482"/>
                <a:gridCol w="1038482"/>
                <a:gridCol w="1038482"/>
                <a:gridCol w="1038482"/>
              </a:tblGrid>
              <a:tr h="12144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Line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Delet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Insert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27,2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,3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6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32,0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,8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2,4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1001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+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57,7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5,9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2,9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1303886"/>
              </p:ext>
            </p:extLst>
          </p:nvPr>
        </p:nvGraphicFramePr>
        <p:xfrm>
          <a:off x="1170035" y="3629062"/>
          <a:ext cx="4305373" cy="133016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21338"/>
                <a:gridCol w="677463"/>
                <a:gridCol w="676643"/>
                <a:gridCol w="676643"/>
                <a:gridCol w="676643"/>
                <a:gridCol w="676643"/>
              </a:tblGrid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Line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Typ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edi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in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ax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err="1">
                          <a:effectLst/>
                        </a:rPr>
                        <a:t>inde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0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inde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9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6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2+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inde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7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27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689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8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3385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 smtClean="0">
                          <a:effectLst/>
                        </a:rPr>
                        <a:t>2+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77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13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</a:tbl>
          </a:graphicData>
        </a:graphic>
      </p:graphicFrame>
      <p:sp>
        <p:nvSpPr>
          <p:cNvPr id="5" name="Content Placeholder 2"/>
          <p:cNvSpPr txBox="1">
            <a:spLocks/>
          </p:cNvSpPr>
          <p:nvPr/>
        </p:nvSpPr>
        <p:spPr>
          <a:xfrm>
            <a:off x="446856" y="3016929"/>
            <a:ext cx="5600286" cy="428380"/>
          </a:xfrm>
          <a:prstGeom prst="rect">
            <a:avLst/>
          </a:prstGeom>
        </p:spPr>
        <p:txBody>
          <a:bodyPr vert="horz" lIns="51435" tIns="25718" rIns="51435" bIns="25718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b="1" dirty="0"/>
              <a:t>b </a:t>
            </a:r>
            <a:r>
              <a:rPr lang="en-US" sz="1400" dirty="0"/>
              <a:t>Number of variants per </a:t>
            </a:r>
            <a:r>
              <a:rPr lang="en-US" sz="1400" dirty="0" smtClean="0"/>
              <a:t>sample;; </a:t>
            </a:r>
            <a:r>
              <a:rPr lang="en-US" sz="1400" dirty="0"/>
              <a:t>variants called in comparison to the </a:t>
            </a:r>
            <a:r>
              <a:rPr lang="en-US" sz="1400" dirty="0" smtClean="0"/>
              <a:t>H37Rv reference, with monomorphic variants removed for each dataset.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375212" y="985246"/>
            <a:ext cx="54946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r>
              <a:rPr lang="en-US" sz="1400" dirty="0" smtClean="0"/>
              <a:t> Total  numbers of variants by </a:t>
            </a:r>
            <a:r>
              <a:rPr lang="en-US" sz="1400" dirty="0"/>
              <a:t>lineage; variants called in comparison to the </a:t>
            </a:r>
            <a:r>
              <a:rPr lang="en-US" sz="1400" dirty="0" smtClean="0"/>
              <a:t>H37Rv </a:t>
            </a:r>
            <a:r>
              <a:rPr lang="en-US" sz="1400" dirty="0"/>
              <a:t>reference, with monomorphic variants removed for each dataset.</a:t>
            </a:r>
          </a:p>
          <a:p>
            <a:endParaRPr lang="en-US" sz="1400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695334"/>
              </p:ext>
            </p:extLst>
          </p:nvPr>
        </p:nvGraphicFramePr>
        <p:xfrm>
          <a:off x="1262338" y="6283168"/>
          <a:ext cx="3969322" cy="94297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67046"/>
                <a:gridCol w="567046"/>
                <a:gridCol w="567046"/>
                <a:gridCol w="567046"/>
                <a:gridCol w="567046"/>
                <a:gridCol w="567046"/>
                <a:gridCol w="567046"/>
              </a:tblGrid>
              <a:tr h="23574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line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e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in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1st Quar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edi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3rd Quar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Max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2144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1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0.00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99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2144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99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  <a:tr h="12144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+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0.00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0.00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>
                          <a:effectLst/>
                        </a:rPr>
                        <a:t>0.998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b"/>
                </a:tc>
              </a:tr>
            </a:tbl>
          </a:graphicData>
        </a:graphic>
      </p:graphicFrame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375212" y="5142983"/>
            <a:ext cx="5915025" cy="1140185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+mn-lt"/>
                <a:ea typeface="Apple Chancery" charset="0"/>
                <a:cs typeface="Apple Chancery" charset="0"/>
              </a:rPr>
              <a:t>c </a:t>
            </a:r>
            <a:r>
              <a:rPr lang="en-US" sz="1400" dirty="0">
                <a:latin typeface="+mn-lt"/>
              </a:rPr>
              <a:t>N</a:t>
            </a:r>
            <a:r>
              <a:rPr lang="en-US" sz="1400" dirty="0" smtClean="0">
                <a:latin typeface="+mn-lt"/>
              </a:rPr>
              <a:t>on-reference variant frequency summary; variants called in comparison to the H37rv reference</a:t>
            </a:r>
            <a:r>
              <a:rPr lang="en-US" sz="1400" dirty="0"/>
              <a:t>; variants called in comparison to the H37rv reference, with monomorphic variants removed for each </a:t>
            </a:r>
            <a:r>
              <a:rPr lang="en-US" sz="1400" dirty="0" smtClean="0"/>
              <a:t>dataset.</a:t>
            </a:r>
            <a:r>
              <a:rPr lang="en-US" sz="1400" dirty="0"/>
              <a:t/>
            </a:r>
            <a:br>
              <a:rPr lang="en-US" sz="1400" dirty="0"/>
            </a:br>
            <a:endParaRPr lang="en-US" sz="1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27634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73</Words>
  <Application>Microsoft Macintosh PowerPoint</Application>
  <PresentationFormat>A4 Paper (210x297 mm)</PresentationFormat>
  <Paragraphs>8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ple Chancery</vt:lpstr>
      <vt:lpstr>Arial</vt:lpstr>
      <vt:lpstr>Calibri</vt:lpstr>
      <vt:lpstr>Calibri Light</vt:lpstr>
      <vt:lpstr>Office Theme</vt:lpstr>
      <vt:lpstr>c Non-reference variant frequency summary; variants called in comparison to the H37rv reference; variants called in comparison to the H37rv reference, with monomorphic variants removed for each dataset. 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9</cp:revision>
  <dcterms:created xsi:type="dcterms:W3CDTF">2018-02-14T14:03:39Z</dcterms:created>
  <dcterms:modified xsi:type="dcterms:W3CDTF">2019-02-18T13:40:12Z</dcterms:modified>
</cp:coreProperties>
</file>